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655" autoAdjust="0"/>
    <p:restoredTop sz="94660"/>
  </p:normalViewPr>
  <p:slideViewPr>
    <p:cSldViewPr>
      <p:cViewPr>
        <p:scale>
          <a:sx n="100" d="100"/>
          <a:sy n="100" d="100"/>
        </p:scale>
        <p:origin x="-1158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47033-D5D1-48AC-B5B2-AAA38CDBE849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BA5C9-E826-4C72-BB88-7734C898A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0875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47033-D5D1-48AC-B5B2-AAA38CDBE849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BA5C9-E826-4C72-BB88-7734C898A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2248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47033-D5D1-48AC-B5B2-AAA38CDBE849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BA5C9-E826-4C72-BB88-7734C898A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63662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47033-D5D1-48AC-B5B2-AAA38CDBE849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BA5C9-E826-4C72-BB88-7734C898A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04144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47033-D5D1-48AC-B5B2-AAA38CDBE849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BA5C9-E826-4C72-BB88-7734C898A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05632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47033-D5D1-48AC-B5B2-AAA38CDBE849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BA5C9-E826-4C72-BB88-7734C898A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49347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47033-D5D1-48AC-B5B2-AAA38CDBE849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BA5C9-E826-4C72-BB88-7734C898A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8158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47033-D5D1-48AC-B5B2-AAA38CDBE849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BA5C9-E826-4C72-BB88-7734C898A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37959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47033-D5D1-48AC-B5B2-AAA38CDBE849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BA5C9-E826-4C72-BB88-7734C898A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93542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47033-D5D1-48AC-B5B2-AAA38CDBE849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BA5C9-E826-4C72-BB88-7734C898A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15787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47033-D5D1-48AC-B5B2-AAA38CDBE849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2BA5C9-E826-4C72-BB88-7734C898A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25678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947033-D5D1-48AC-B5B2-AAA38CDBE849}" type="datetimeFigureOut">
              <a:rPr lang="en-US" smtClean="0"/>
              <a:t>11/13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2BA5C9-E826-4C72-BB88-7734C898A9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60441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TextBox 33"/>
          <p:cNvSpPr txBox="1"/>
          <p:nvPr/>
        </p:nvSpPr>
        <p:spPr>
          <a:xfrm>
            <a:off x="2057400" y="0"/>
            <a:ext cx="18942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upplementary Table ST2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35" name="Table 3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61119608"/>
              </p:ext>
            </p:extLst>
          </p:nvPr>
        </p:nvGraphicFramePr>
        <p:xfrm>
          <a:off x="533400" y="533400"/>
          <a:ext cx="5486400" cy="82143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838200"/>
                <a:gridCol w="457200"/>
                <a:gridCol w="685800"/>
                <a:gridCol w="1066800"/>
                <a:gridCol w="1219200"/>
                <a:gridCol w="1219200"/>
              </a:tblGrid>
              <a:tr h="533400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Times New Roman" pitchFamily="18" charset="0"/>
                          <a:cs typeface="Times New Roman" pitchFamily="18" charset="0"/>
                        </a:rPr>
                        <a:t>Cytokine</a:t>
                      </a:r>
                      <a:endParaRPr lang="en-US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Times New Roman" pitchFamily="18" charset="0"/>
                          <a:cs typeface="Times New Roman" pitchFamily="18" charset="0"/>
                        </a:rPr>
                        <a:t>Vehicle</a:t>
                      </a:r>
                      <a:endParaRPr lang="en-US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Times New Roman" pitchFamily="18" charset="0"/>
                          <a:cs typeface="Times New Roman" pitchFamily="18" charset="0"/>
                        </a:rPr>
                        <a:t>Carrageenan</a:t>
                      </a:r>
                      <a:endParaRPr lang="en-US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Times New Roman" pitchFamily="18" charset="0"/>
                          <a:cs typeface="Times New Roman" pitchFamily="18" charset="0"/>
                        </a:rPr>
                        <a:t>GTx-186+</a:t>
                      </a:r>
                    </a:p>
                    <a:p>
                      <a:pPr algn="ctr"/>
                      <a:r>
                        <a:rPr lang="en-US" sz="1200" b="1" dirty="0" smtClean="0">
                          <a:latin typeface="Times New Roman" pitchFamily="18" charset="0"/>
                          <a:cs typeface="Times New Roman" pitchFamily="18" charset="0"/>
                        </a:rPr>
                        <a:t>Carrageenan</a:t>
                      </a:r>
                      <a:endParaRPr lang="en-US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err="1" smtClean="0">
                          <a:latin typeface="Times New Roman" pitchFamily="18" charset="0"/>
                          <a:cs typeface="Times New Roman" pitchFamily="18" charset="0"/>
                        </a:rPr>
                        <a:t>Indomethacin+Carrageenan</a:t>
                      </a:r>
                      <a:endParaRPr lang="en-US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182880"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Activin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Avg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121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156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97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123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</a:tr>
              <a:tr h="182880">
                <a:tc v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S.E.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11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08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04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18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</a:tr>
              <a:tr h="182880"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Agrin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Avg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144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195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117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149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182880">
                <a:tc v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S.E.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07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07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16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31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182880"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B7-2/CD86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Avg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102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160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73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744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</a:tr>
              <a:tr h="182880">
                <a:tc v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S.E.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056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07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21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24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</a:tr>
              <a:tr h="182880"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CINC-1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Avg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82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460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183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441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182880">
                <a:tc v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S.E.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056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06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21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34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182880"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CINC-2a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Avg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96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273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166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252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</a:tr>
              <a:tr h="182880">
                <a:tc v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S.E.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035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08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13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27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</a:tr>
              <a:tr h="182880"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CINC-3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Avg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19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269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225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262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182880">
                <a:tc v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S.E.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06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099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21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28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182880"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CNTF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Avg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14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299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27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27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</a:tr>
              <a:tr h="182880">
                <a:tc v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S.E.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012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16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019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13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</a:tr>
              <a:tr h="182880"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Fractalkine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Avg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236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467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322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25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182880">
                <a:tc v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S.E.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027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12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11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13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182880"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IL-1</a:t>
                      </a:r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  <a:sym typeface="Symbol"/>
                        </a:rPr>
                        <a:t>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Avg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107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141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872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106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</a:tr>
              <a:tr h="182880">
                <a:tc v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S.E.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12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17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04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28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</a:tr>
              <a:tr h="182880"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IL-1</a:t>
                      </a:r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  <a:sym typeface="Symbol"/>
                        </a:rPr>
                        <a:t>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Avg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45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87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45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64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182880">
                <a:tc v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S.E.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02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17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094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12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182880"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IL-6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Avg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141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273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183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260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</a:tr>
              <a:tr h="182880">
                <a:tc v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S.E.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08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05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21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42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</a:tr>
              <a:tr h="182880"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IL-13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Avg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35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65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38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126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182880">
                <a:tc v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S.E.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05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076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12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05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182880"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Leptin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Avg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43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64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38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24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</a:tr>
              <a:tr h="182880">
                <a:tc v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S.E.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048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036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06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12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</a:tr>
              <a:tr h="182880"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LIX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Avg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186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333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233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333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182880">
                <a:tc v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S.E.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23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16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19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06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2239261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413910"/>
              </p:ext>
            </p:extLst>
          </p:nvPr>
        </p:nvGraphicFramePr>
        <p:xfrm>
          <a:off x="533400" y="533400"/>
          <a:ext cx="5486400" cy="43738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838200"/>
                <a:gridCol w="457200"/>
                <a:gridCol w="685800"/>
                <a:gridCol w="1066800"/>
                <a:gridCol w="1219200"/>
                <a:gridCol w="1219200"/>
              </a:tblGrid>
              <a:tr h="533400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Times New Roman" pitchFamily="18" charset="0"/>
                          <a:cs typeface="Times New Roman" pitchFamily="18" charset="0"/>
                        </a:rPr>
                        <a:t>Cytokine</a:t>
                      </a:r>
                      <a:endParaRPr lang="en-US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US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Times New Roman" pitchFamily="18" charset="0"/>
                          <a:cs typeface="Times New Roman" pitchFamily="18" charset="0"/>
                        </a:rPr>
                        <a:t>Vehicle</a:t>
                      </a:r>
                      <a:endParaRPr lang="en-US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Times New Roman" pitchFamily="18" charset="0"/>
                          <a:cs typeface="Times New Roman" pitchFamily="18" charset="0"/>
                        </a:rPr>
                        <a:t>Carrageenan</a:t>
                      </a:r>
                      <a:endParaRPr lang="en-US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Times New Roman" pitchFamily="18" charset="0"/>
                          <a:cs typeface="Times New Roman" pitchFamily="18" charset="0"/>
                        </a:rPr>
                        <a:t>GTx-186+</a:t>
                      </a:r>
                    </a:p>
                    <a:p>
                      <a:pPr algn="ctr"/>
                      <a:r>
                        <a:rPr lang="en-US" sz="1200" b="1" dirty="0" smtClean="0">
                          <a:latin typeface="Times New Roman" pitchFamily="18" charset="0"/>
                          <a:cs typeface="Times New Roman" pitchFamily="18" charset="0"/>
                        </a:rPr>
                        <a:t>Carrageenan</a:t>
                      </a:r>
                      <a:endParaRPr lang="en-US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err="1" smtClean="0">
                          <a:latin typeface="Times New Roman" pitchFamily="18" charset="0"/>
                          <a:cs typeface="Times New Roman" pitchFamily="18" charset="0"/>
                        </a:rPr>
                        <a:t>Indomethacin+Carrageenan</a:t>
                      </a:r>
                      <a:endParaRPr lang="en-US" sz="12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182880"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MCP-1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Avg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187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564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413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563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</a:tr>
              <a:tr h="182880">
                <a:tc v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S.E.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17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36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43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6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</a:tr>
              <a:tr h="182880"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MIP-3</a:t>
                      </a:r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  <a:sym typeface="Symbol"/>
                        </a:rPr>
                        <a:t>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Avg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186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251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192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231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182880">
                <a:tc v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S.E.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22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15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09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31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182880"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MMP-8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Avg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103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978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946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826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</a:tr>
              <a:tr h="182880">
                <a:tc v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S.E.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06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64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5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82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</a:tr>
              <a:tr h="182880"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PDGFaa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Avg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79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236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195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164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182880">
                <a:tc v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S.E.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082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06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13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31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182880"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TIMP-1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Avg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159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539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461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438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</a:tr>
              <a:tr h="182880">
                <a:tc v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S.E.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09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68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3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41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</a:tr>
              <a:tr h="182880"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TNF-</a:t>
                      </a:r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  <a:sym typeface="Symbol"/>
                        </a:rPr>
                        <a:t>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Avg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57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.271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82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93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182880">
                <a:tc v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S.E.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13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25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08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33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</a:tr>
              <a:tr h="182880"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VEGF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Avg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58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124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105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75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</a:tr>
              <a:tr h="182880">
                <a:tc v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S.E.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05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14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038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Times New Roman" pitchFamily="18" charset="0"/>
                          <a:cs typeface="Times New Roman" pitchFamily="18" charset="0"/>
                        </a:rPr>
                        <a:t>0.015</a:t>
                      </a:r>
                      <a:endParaRPr lang="en-US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057400" y="0"/>
            <a:ext cx="22949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upplementary Table ST2 Cont.</a:t>
            </a:r>
            <a:endParaRPr 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651773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6</TotalTime>
  <Words>279</Words>
  <Application>Microsoft Office PowerPoint</Application>
  <PresentationFormat>On-screen Show (4:3)</PresentationFormat>
  <Paragraphs>245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GTx, Inc.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mesh Narayanan</dc:creator>
  <cp:lastModifiedBy>Ramesh Narayanan</cp:lastModifiedBy>
  <cp:revision>34</cp:revision>
  <dcterms:created xsi:type="dcterms:W3CDTF">2012-07-24T16:37:13Z</dcterms:created>
  <dcterms:modified xsi:type="dcterms:W3CDTF">2013-11-13T17:12:55Z</dcterms:modified>
</cp:coreProperties>
</file>